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60"/>
  </p:normalViewPr>
  <p:slideViewPr>
    <p:cSldViewPr snapToGrid="0">
      <p:cViewPr varScale="1">
        <p:scale>
          <a:sx n="51" d="100"/>
          <a:sy n="51" d="100"/>
        </p:scale>
        <p:origin x="24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A08C4F6-1F4F-4BD9-B834-462059E29226}"/>
              </a:ext>
            </a:extLst>
          </p:cNvPr>
          <p:cNvSpPr txBox="1"/>
          <p:nvPr/>
        </p:nvSpPr>
        <p:spPr>
          <a:xfrm>
            <a:off x="62970" y="85973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/>
              <a:t>Supplementary Fig. 11</a:t>
            </a:r>
            <a:endParaRPr kumimoji="1" lang="ja-JP" altLang="en-US" b="1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980C6B1-2010-40BD-87C1-A584716E577A}"/>
              </a:ext>
            </a:extLst>
          </p:cNvPr>
          <p:cNvSpPr txBox="1"/>
          <p:nvPr/>
        </p:nvSpPr>
        <p:spPr>
          <a:xfrm>
            <a:off x="1516433" y="8602046"/>
            <a:ext cx="135485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urvival time in days</a:t>
            </a:r>
            <a:endParaRPr kumimoji="1" lang="ja-JP" altLang="en-US" sz="1100" dirty="0"/>
          </a:p>
        </p:txBody>
      </p: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id="{0936A096-F05B-4AE3-8ECF-A7D6586E37D4}"/>
              </a:ext>
            </a:extLst>
          </p:cNvPr>
          <p:cNvGrpSpPr/>
          <p:nvPr/>
        </p:nvGrpSpPr>
        <p:grpSpPr>
          <a:xfrm>
            <a:off x="660986" y="3704655"/>
            <a:ext cx="2763185" cy="2374835"/>
            <a:chOff x="219684" y="3704061"/>
            <a:chExt cx="3100780" cy="2664984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2BAC49E7-4C80-4E6C-AFDE-318A5446030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19" y="3704061"/>
              <a:ext cx="3030945" cy="2548520"/>
            </a:xfrm>
            <a:prstGeom prst="rect">
              <a:avLst/>
            </a:prstGeom>
          </p:spPr>
        </p:pic>
        <p:sp>
          <p:nvSpPr>
            <p:cNvPr id="144" name="正方形/長方形 143">
              <a:extLst>
                <a:ext uri="{FF2B5EF4-FFF2-40B4-BE49-F238E27FC236}">
                  <a16:creationId xmlns:a16="http://schemas.microsoft.com/office/drawing/2014/main" id="{799B008C-9F54-4F92-958F-5B483D7076BB}"/>
                </a:ext>
              </a:extLst>
            </p:cNvPr>
            <p:cNvSpPr/>
            <p:nvPr/>
          </p:nvSpPr>
          <p:spPr>
            <a:xfrm>
              <a:off x="661061" y="6017450"/>
              <a:ext cx="2642437" cy="3515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5" name="正方形/長方形 144">
              <a:extLst>
                <a:ext uri="{FF2B5EF4-FFF2-40B4-BE49-F238E27FC236}">
                  <a16:creationId xmlns:a16="http://schemas.microsoft.com/office/drawing/2014/main" id="{1CDEBA49-346D-4B72-95A0-166364BCC935}"/>
                </a:ext>
              </a:extLst>
            </p:cNvPr>
            <p:cNvSpPr/>
            <p:nvPr/>
          </p:nvSpPr>
          <p:spPr>
            <a:xfrm>
              <a:off x="219684" y="3726705"/>
              <a:ext cx="449708" cy="2355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35A6F472-A9B2-4E43-803F-C21A74057A3C}"/>
              </a:ext>
            </a:extLst>
          </p:cNvPr>
          <p:cNvGrpSpPr/>
          <p:nvPr/>
        </p:nvGrpSpPr>
        <p:grpSpPr>
          <a:xfrm>
            <a:off x="972422" y="3749129"/>
            <a:ext cx="2363363" cy="2064813"/>
            <a:chOff x="569170" y="3753969"/>
            <a:chExt cx="2652109" cy="2317085"/>
          </a:xfrm>
        </p:grpSpPr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E9055F6D-2C69-420B-94C0-13443E9C344F}"/>
                </a:ext>
              </a:extLst>
            </p:cNvPr>
            <p:cNvSpPr/>
            <p:nvPr/>
          </p:nvSpPr>
          <p:spPr>
            <a:xfrm>
              <a:off x="622079" y="3753969"/>
              <a:ext cx="2599200" cy="2268000"/>
            </a:xfrm>
            <a:custGeom>
              <a:avLst/>
              <a:gdLst>
                <a:gd name="connsiteX0" fmla="*/ 0 w 2324025"/>
                <a:gd name="connsiteY0" fmla="*/ 0 h 2018243"/>
                <a:gd name="connsiteX1" fmla="*/ 2324025 w 2324025"/>
                <a:gd name="connsiteY1" fmla="*/ 0 h 2018243"/>
                <a:gd name="connsiteX2" fmla="*/ 2324025 w 2324025"/>
                <a:gd name="connsiteY2" fmla="*/ 2018243 h 2018243"/>
                <a:gd name="connsiteX3" fmla="*/ 0 w 2324025"/>
                <a:gd name="connsiteY3" fmla="*/ 2018243 h 2018243"/>
                <a:gd name="connsiteX4" fmla="*/ 0 w 2324025"/>
                <a:gd name="connsiteY4" fmla="*/ 0 h 2018243"/>
                <a:gd name="connsiteX0" fmla="*/ 0 w 2324025"/>
                <a:gd name="connsiteY0" fmla="*/ 0 h 2018243"/>
                <a:gd name="connsiteX1" fmla="*/ 2324025 w 2324025"/>
                <a:gd name="connsiteY1" fmla="*/ 2018243 h 2018243"/>
                <a:gd name="connsiteX2" fmla="*/ 0 w 2324025"/>
                <a:gd name="connsiteY2" fmla="*/ 2018243 h 2018243"/>
                <a:gd name="connsiteX3" fmla="*/ 0 w 2324025"/>
                <a:gd name="connsiteY3" fmla="*/ 0 h 2018243"/>
                <a:gd name="connsiteX0" fmla="*/ 2324025 w 2415465"/>
                <a:gd name="connsiteY0" fmla="*/ 2018243 h 2109683"/>
                <a:gd name="connsiteX1" fmla="*/ 0 w 2415465"/>
                <a:gd name="connsiteY1" fmla="*/ 2018243 h 2109683"/>
                <a:gd name="connsiteX2" fmla="*/ 0 w 2415465"/>
                <a:gd name="connsiteY2" fmla="*/ 0 h 2109683"/>
                <a:gd name="connsiteX3" fmla="*/ 2415465 w 2415465"/>
                <a:gd name="connsiteY3" fmla="*/ 2109683 h 2109683"/>
                <a:gd name="connsiteX0" fmla="*/ 2324025 w 2324025"/>
                <a:gd name="connsiteY0" fmla="*/ 2018243 h 2018243"/>
                <a:gd name="connsiteX1" fmla="*/ 0 w 2324025"/>
                <a:gd name="connsiteY1" fmla="*/ 2018243 h 2018243"/>
                <a:gd name="connsiteX2" fmla="*/ 0 w 2324025"/>
                <a:gd name="connsiteY2" fmla="*/ 0 h 20182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24025" h="2018243">
                  <a:moveTo>
                    <a:pt x="2324025" y="2018243"/>
                  </a:moveTo>
                  <a:lnTo>
                    <a:pt x="0" y="201824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27272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F3EAF0D0-CA04-48B6-B068-9D890DF9BD3A}"/>
                </a:ext>
              </a:extLst>
            </p:cNvPr>
            <p:cNvGrpSpPr/>
            <p:nvPr/>
          </p:nvGrpSpPr>
          <p:grpSpPr>
            <a:xfrm>
              <a:off x="569170" y="3846102"/>
              <a:ext cx="54000" cy="2090986"/>
              <a:chOff x="569170" y="3846102"/>
              <a:chExt cx="54000" cy="2090986"/>
            </a:xfrm>
          </p:grpSpPr>
          <p:cxnSp>
            <p:nvCxnSpPr>
              <p:cNvPr id="5" name="直線コネクタ 4">
                <a:extLst>
                  <a:ext uri="{FF2B5EF4-FFF2-40B4-BE49-F238E27FC236}">
                    <a16:creationId xmlns:a16="http://schemas.microsoft.com/office/drawing/2014/main" id="{81E16873-84D8-41DF-89C1-F15275A3B7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3846102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BE3F98E0-94C0-4B80-95DE-B1D3D26EFC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264299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2DF67750-C776-4BCB-B5CF-DCB697C7F5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682496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231306BD-90B0-4C16-AA93-44A0BF43C4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100693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45F4BFD0-A56C-43FD-A279-02C463E1AC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518890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BF50EEE7-5621-48C5-A796-D422612D21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937088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4C7BB2C1-E402-4CD2-950E-3B594F837C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7722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785AD428-C595-4C4D-9354-28C21B7E74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38154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F91F2E36-FB17-4C2F-BC2D-7453ED2A25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58586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80E5AFAD-CD0D-4F41-8163-75175457AB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79018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250E5180-FE72-47D7-8230-20BB3CF8D8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99450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565B3894-69EC-49C1-B116-6FC167A7D8D6}"/>
              </a:ext>
            </a:extLst>
          </p:cNvPr>
          <p:cNvSpPr txBox="1"/>
          <p:nvPr/>
        </p:nvSpPr>
        <p:spPr>
          <a:xfrm>
            <a:off x="660254" y="5557072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0</a:t>
            </a:r>
            <a:endParaRPr kumimoji="1" lang="ja-JP" altLang="en-US" sz="1100" dirty="0"/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290F92CD-9F01-4946-B4C9-361A08C009EF}"/>
              </a:ext>
            </a:extLst>
          </p:cNvPr>
          <p:cNvSpPr txBox="1"/>
          <p:nvPr/>
        </p:nvSpPr>
        <p:spPr>
          <a:xfrm>
            <a:off x="660254" y="5185779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2</a:t>
            </a:r>
            <a:endParaRPr kumimoji="1" lang="ja-JP" altLang="en-US" sz="1100" dirty="0"/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6AC2DE65-38D2-4CC6-B168-99F0392206FB}"/>
              </a:ext>
            </a:extLst>
          </p:cNvPr>
          <p:cNvSpPr txBox="1"/>
          <p:nvPr/>
        </p:nvSpPr>
        <p:spPr>
          <a:xfrm>
            <a:off x="660254" y="481448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4</a:t>
            </a:r>
            <a:endParaRPr kumimoji="1" lang="ja-JP" altLang="en-US" sz="1100" dirty="0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5387CCD9-AA59-4BCB-B58F-A67C9B38E2F3}"/>
              </a:ext>
            </a:extLst>
          </p:cNvPr>
          <p:cNvSpPr txBox="1"/>
          <p:nvPr/>
        </p:nvSpPr>
        <p:spPr>
          <a:xfrm>
            <a:off x="660254" y="4443195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6</a:t>
            </a:r>
            <a:endParaRPr kumimoji="1" lang="ja-JP" altLang="en-US" sz="1100" dirty="0"/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6541D80E-F839-436F-9275-552F7A1FA6C5}"/>
              </a:ext>
            </a:extLst>
          </p:cNvPr>
          <p:cNvSpPr txBox="1"/>
          <p:nvPr/>
        </p:nvSpPr>
        <p:spPr>
          <a:xfrm>
            <a:off x="660254" y="407190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8</a:t>
            </a:r>
            <a:endParaRPr kumimoji="1" lang="ja-JP" altLang="en-US" sz="1100" dirty="0"/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AD1F7188-E17E-4880-8A01-558AA67F80E2}"/>
              </a:ext>
            </a:extLst>
          </p:cNvPr>
          <p:cNvSpPr txBox="1"/>
          <p:nvPr/>
        </p:nvSpPr>
        <p:spPr>
          <a:xfrm>
            <a:off x="660254" y="3700611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.0</a:t>
            </a:r>
            <a:endParaRPr kumimoji="1" lang="ja-JP" altLang="en-US" sz="1100" dirty="0"/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783C8F16-78A9-4E9D-B617-63F9CAFD2224}"/>
              </a:ext>
            </a:extLst>
          </p:cNvPr>
          <p:cNvSpPr txBox="1"/>
          <p:nvPr/>
        </p:nvSpPr>
        <p:spPr>
          <a:xfrm>
            <a:off x="983348" y="5798260"/>
            <a:ext cx="2772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</a:t>
            </a:r>
            <a:endParaRPr kumimoji="1" lang="ja-JP" altLang="en-US" sz="1100" dirty="0"/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AB98DBD8-DFB9-4B24-AC6D-5A9CCFD23159}"/>
              </a:ext>
            </a:extLst>
          </p:cNvPr>
          <p:cNvSpPr txBox="1"/>
          <p:nvPr/>
        </p:nvSpPr>
        <p:spPr>
          <a:xfrm>
            <a:off x="1447240" y="5798260"/>
            <a:ext cx="432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500</a:t>
            </a:r>
            <a:endParaRPr kumimoji="1" lang="ja-JP" altLang="en-US" sz="1100" dirty="0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78733E2B-F948-4468-AF40-24365C0D73D0}"/>
              </a:ext>
            </a:extLst>
          </p:cNvPr>
          <p:cNvSpPr txBox="1"/>
          <p:nvPr/>
        </p:nvSpPr>
        <p:spPr>
          <a:xfrm>
            <a:off x="1964416" y="5798260"/>
            <a:ext cx="510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000</a:t>
            </a:r>
            <a:endParaRPr kumimoji="1" lang="ja-JP" altLang="en-US" sz="1100" dirty="0"/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C8E1E06A-A597-4B3C-A600-EAB629B07BF0}"/>
              </a:ext>
            </a:extLst>
          </p:cNvPr>
          <p:cNvSpPr txBox="1"/>
          <p:nvPr/>
        </p:nvSpPr>
        <p:spPr>
          <a:xfrm>
            <a:off x="2532732" y="5798260"/>
            <a:ext cx="510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500</a:t>
            </a:r>
            <a:endParaRPr kumimoji="1" lang="ja-JP" altLang="en-US" sz="1100" dirty="0"/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401B5FC2-FBF5-4010-9AD9-960EE98A771A}"/>
              </a:ext>
            </a:extLst>
          </p:cNvPr>
          <p:cNvSpPr txBox="1"/>
          <p:nvPr/>
        </p:nvSpPr>
        <p:spPr>
          <a:xfrm>
            <a:off x="3064491" y="5798260"/>
            <a:ext cx="510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2000</a:t>
            </a:r>
            <a:endParaRPr kumimoji="1" lang="ja-JP" altLang="en-US" sz="11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A009573-3B7A-4E00-BE6C-1CEEB4E1237B}"/>
              </a:ext>
            </a:extLst>
          </p:cNvPr>
          <p:cNvSpPr txBox="1"/>
          <p:nvPr/>
        </p:nvSpPr>
        <p:spPr>
          <a:xfrm>
            <a:off x="2655735" y="3541311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Stage II</a:t>
            </a:r>
            <a:endParaRPr kumimoji="1" lang="ja-JP" altLang="en-US" sz="1100" b="1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9A144D8-1CEE-45EB-8132-B3B72CF9A1F6}"/>
              </a:ext>
            </a:extLst>
          </p:cNvPr>
          <p:cNvSpPr txBox="1"/>
          <p:nvPr/>
        </p:nvSpPr>
        <p:spPr>
          <a:xfrm>
            <a:off x="2614793" y="4099226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/>
              <a:t>P</a:t>
            </a:r>
            <a:r>
              <a:rPr kumimoji="1" lang="en-US" altLang="ja-JP" sz="1100" dirty="0"/>
              <a:t>=0.358</a:t>
            </a:r>
            <a:endParaRPr kumimoji="1" lang="ja-JP" altLang="en-US" sz="1100" dirty="0"/>
          </a:p>
        </p:txBody>
      </p:sp>
      <p:grpSp>
        <p:nvGrpSpPr>
          <p:cNvPr id="148" name="グループ化 147">
            <a:extLst>
              <a:ext uri="{FF2B5EF4-FFF2-40B4-BE49-F238E27FC236}">
                <a16:creationId xmlns:a16="http://schemas.microsoft.com/office/drawing/2014/main" id="{ADC06127-E0C6-4E81-B0A9-67F510802DBD}"/>
              </a:ext>
            </a:extLst>
          </p:cNvPr>
          <p:cNvGrpSpPr/>
          <p:nvPr/>
        </p:nvGrpSpPr>
        <p:grpSpPr>
          <a:xfrm>
            <a:off x="655674" y="1099383"/>
            <a:ext cx="2742780" cy="2402831"/>
            <a:chOff x="396854" y="738055"/>
            <a:chExt cx="3077881" cy="2696400"/>
          </a:xfrm>
        </p:grpSpPr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BC15834E-AA6D-4851-A8EC-486DDD09F1A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1601" y="738055"/>
              <a:ext cx="3033134" cy="2696400"/>
            </a:xfrm>
            <a:prstGeom prst="rect">
              <a:avLst/>
            </a:prstGeom>
          </p:spPr>
        </p:pic>
        <p:sp>
          <p:nvSpPr>
            <p:cNvPr id="142" name="正方形/長方形 141">
              <a:extLst>
                <a:ext uri="{FF2B5EF4-FFF2-40B4-BE49-F238E27FC236}">
                  <a16:creationId xmlns:a16="http://schemas.microsoft.com/office/drawing/2014/main" id="{85387F2A-38CF-4E97-930C-B3AFB7F6F305}"/>
                </a:ext>
              </a:extLst>
            </p:cNvPr>
            <p:cNvSpPr/>
            <p:nvPr/>
          </p:nvSpPr>
          <p:spPr>
            <a:xfrm>
              <a:off x="806641" y="3068750"/>
              <a:ext cx="2642437" cy="3515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3" name="正方形/長方形 142">
              <a:extLst>
                <a:ext uri="{FF2B5EF4-FFF2-40B4-BE49-F238E27FC236}">
                  <a16:creationId xmlns:a16="http://schemas.microsoft.com/office/drawing/2014/main" id="{608E9BD4-1BE1-4F77-9982-FC4B7766BF07}"/>
                </a:ext>
              </a:extLst>
            </p:cNvPr>
            <p:cNvSpPr/>
            <p:nvPr/>
          </p:nvSpPr>
          <p:spPr>
            <a:xfrm>
              <a:off x="396854" y="787939"/>
              <a:ext cx="449708" cy="2355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6BEC96D8-C3D0-4A41-8AC0-A947D6AE5B14}"/>
              </a:ext>
            </a:extLst>
          </p:cNvPr>
          <p:cNvGrpSpPr/>
          <p:nvPr/>
        </p:nvGrpSpPr>
        <p:grpSpPr>
          <a:xfrm>
            <a:off x="973697" y="1165668"/>
            <a:ext cx="2363363" cy="2064814"/>
            <a:chOff x="569170" y="3753969"/>
            <a:chExt cx="2652109" cy="2317085"/>
          </a:xfrm>
        </p:grpSpPr>
        <p:sp>
          <p:nvSpPr>
            <p:cNvPr id="67" name="正方形/長方形 1">
              <a:extLst>
                <a:ext uri="{FF2B5EF4-FFF2-40B4-BE49-F238E27FC236}">
                  <a16:creationId xmlns:a16="http://schemas.microsoft.com/office/drawing/2014/main" id="{7599725C-5688-4BE0-8E51-9DB8ECA1CAC5}"/>
                </a:ext>
              </a:extLst>
            </p:cNvPr>
            <p:cNvSpPr/>
            <p:nvPr/>
          </p:nvSpPr>
          <p:spPr>
            <a:xfrm>
              <a:off x="622079" y="3753969"/>
              <a:ext cx="2599200" cy="2268000"/>
            </a:xfrm>
            <a:custGeom>
              <a:avLst/>
              <a:gdLst>
                <a:gd name="connsiteX0" fmla="*/ 0 w 2324025"/>
                <a:gd name="connsiteY0" fmla="*/ 0 h 2018243"/>
                <a:gd name="connsiteX1" fmla="*/ 2324025 w 2324025"/>
                <a:gd name="connsiteY1" fmla="*/ 0 h 2018243"/>
                <a:gd name="connsiteX2" fmla="*/ 2324025 w 2324025"/>
                <a:gd name="connsiteY2" fmla="*/ 2018243 h 2018243"/>
                <a:gd name="connsiteX3" fmla="*/ 0 w 2324025"/>
                <a:gd name="connsiteY3" fmla="*/ 2018243 h 2018243"/>
                <a:gd name="connsiteX4" fmla="*/ 0 w 2324025"/>
                <a:gd name="connsiteY4" fmla="*/ 0 h 2018243"/>
                <a:gd name="connsiteX0" fmla="*/ 0 w 2324025"/>
                <a:gd name="connsiteY0" fmla="*/ 0 h 2018243"/>
                <a:gd name="connsiteX1" fmla="*/ 2324025 w 2324025"/>
                <a:gd name="connsiteY1" fmla="*/ 2018243 h 2018243"/>
                <a:gd name="connsiteX2" fmla="*/ 0 w 2324025"/>
                <a:gd name="connsiteY2" fmla="*/ 2018243 h 2018243"/>
                <a:gd name="connsiteX3" fmla="*/ 0 w 2324025"/>
                <a:gd name="connsiteY3" fmla="*/ 0 h 2018243"/>
                <a:gd name="connsiteX0" fmla="*/ 2324025 w 2415465"/>
                <a:gd name="connsiteY0" fmla="*/ 2018243 h 2109683"/>
                <a:gd name="connsiteX1" fmla="*/ 0 w 2415465"/>
                <a:gd name="connsiteY1" fmla="*/ 2018243 h 2109683"/>
                <a:gd name="connsiteX2" fmla="*/ 0 w 2415465"/>
                <a:gd name="connsiteY2" fmla="*/ 0 h 2109683"/>
                <a:gd name="connsiteX3" fmla="*/ 2415465 w 2415465"/>
                <a:gd name="connsiteY3" fmla="*/ 2109683 h 2109683"/>
                <a:gd name="connsiteX0" fmla="*/ 2324025 w 2324025"/>
                <a:gd name="connsiteY0" fmla="*/ 2018243 h 2018243"/>
                <a:gd name="connsiteX1" fmla="*/ 0 w 2324025"/>
                <a:gd name="connsiteY1" fmla="*/ 2018243 h 2018243"/>
                <a:gd name="connsiteX2" fmla="*/ 0 w 2324025"/>
                <a:gd name="connsiteY2" fmla="*/ 0 h 20182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24025" h="2018243">
                  <a:moveTo>
                    <a:pt x="2324025" y="2018243"/>
                  </a:moveTo>
                  <a:lnTo>
                    <a:pt x="0" y="201824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27272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14372AD2-50C7-4629-921F-9137FA7DB06F}"/>
                </a:ext>
              </a:extLst>
            </p:cNvPr>
            <p:cNvGrpSpPr/>
            <p:nvPr/>
          </p:nvGrpSpPr>
          <p:grpSpPr>
            <a:xfrm>
              <a:off x="569170" y="3846102"/>
              <a:ext cx="54000" cy="2090986"/>
              <a:chOff x="569170" y="3846102"/>
              <a:chExt cx="54000" cy="2090986"/>
            </a:xfrm>
          </p:grpSpPr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id="{78662A10-4219-430E-8EAF-4E54603248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3846102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id="{2379C253-CC7E-4DD3-B770-C331866F98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264299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C495EE9B-5A4B-420B-93B6-961ACC9DD1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682496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id="{3B4AFED8-8656-4A81-BFAF-695E9E28D7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100693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7DF75B8D-8790-4D55-80EC-8FFF385C5C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518890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コネクタ 78">
                <a:extLst>
                  <a:ext uri="{FF2B5EF4-FFF2-40B4-BE49-F238E27FC236}">
                    <a16:creationId xmlns:a16="http://schemas.microsoft.com/office/drawing/2014/main" id="{388C5D29-A8D6-4BB0-9DF7-33AE326D22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937088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49FEB36E-BA74-45C6-9E73-D8759BB460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7722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C8C1571C-9260-484B-BF01-BBB34FC397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10111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073E45A0-BED2-4154-803F-13C07D6792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02500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C736CACD-91F2-453A-93E3-AE6947028C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4890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1DA5163B-17D0-4F70-82B4-6685651BC81C}"/>
              </a:ext>
            </a:extLst>
          </p:cNvPr>
          <p:cNvSpPr txBox="1"/>
          <p:nvPr/>
        </p:nvSpPr>
        <p:spPr>
          <a:xfrm>
            <a:off x="660254" y="2974955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0</a:t>
            </a:r>
            <a:endParaRPr kumimoji="1" lang="ja-JP" altLang="en-US" sz="1100" dirty="0"/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BA46D9CE-92D4-4EAD-9425-D2AAF462D8EA}"/>
              </a:ext>
            </a:extLst>
          </p:cNvPr>
          <p:cNvSpPr txBox="1"/>
          <p:nvPr/>
        </p:nvSpPr>
        <p:spPr>
          <a:xfrm>
            <a:off x="660254" y="2603662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2</a:t>
            </a:r>
            <a:endParaRPr kumimoji="1" lang="ja-JP" altLang="en-US" sz="1100" dirty="0"/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91BA0A20-980F-443B-85F3-EAF946DF3830}"/>
              </a:ext>
            </a:extLst>
          </p:cNvPr>
          <p:cNvSpPr txBox="1"/>
          <p:nvPr/>
        </p:nvSpPr>
        <p:spPr>
          <a:xfrm>
            <a:off x="660254" y="2232370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4</a:t>
            </a:r>
            <a:endParaRPr kumimoji="1" lang="ja-JP" altLang="en-US" sz="1100" dirty="0"/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444A2A80-A890-4145-8420-0CD3670C7BBA}"/>
              </a:ext>
            </a:extLst>
          </p:cNvPr>
          <p:cNvSpPr txBox="1"/>
          <p:nvPr/>
        </p:nvSpPr>
        <p:spPr>
          <a:xfrm>
            <a:off x="660254" y="1861078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6</a:t>
            </a:r>
            <a:endParaRPr kumimoji="1" lang="ja-JP" altLang="en-US" sz="1100" dirty="0"/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82012859-8281-42E4-8E0D-160E5E253A9D}"/>
              </a:ext>
            </a:extLst>
          </p:cNvPr>
          <p:cNvSpPr txBox="1"/>
          <p:nvPr/>
        </p:nvSpPr>
        <p:spPr>
          <a:xfrm>
            <a:off x="660254" y="1489786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8</a:t>
            </a:r>
            <a:endParaRPr kumimoji="1" lang="ja-JP" altLang="en-US" sz="1100" dirty="0"/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8C607308-7BC2-4EFB-84D7-01447E42B176}"/>
              </a:ext>
            </a:extLst>
          </p:cNvPr>
          <p:cNvSpPr txBox="1"/>
          <p:nvPr/>
        </p:nvSpPr>
        <p:spPr>
          <a:xfrm>
            <a:off x="660254" y="1118494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.0</a:t>
            </a:r>
            <a:endParaRPr kumimoji="1" lang="ja-JP" altLang="en-US" sz="1100" dirty="0"/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C7912579-671A-476B-9138-53277D69FD29}"/>
              </a:ext>
            </a:extLst>
          </p:cNvPr>
          <p:cNvSpPr txBox="1"/>
          <p:nvPr/>
        </p:nvSpPr>
        <p:spPr>
          <a:xfrm>
            <a:off x="974701" y="3199530"/>
            <a:ext cx="3100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</a:t>
            </a:r>
            <a:endParaRPr kumimoji="1" lang="ja-JP" altLang="en-US" sz="1100" dirty="0"/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B558FDE6-06B9-442D-A9B9-AB266FB1291C}"/>
              </a:ext>
            </a:extLst>
          </p:cNvPr>
          <p:cNvSpPr txBox="1"/>
          <p:nvPr/>
        </p:nvSpPr>
        <p:spPr>
          <a:xfrm>
            <a:off x="1493479" y="3199530"/>
            <a:ext cx="4842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500</a:t>
            </a:r>
            <a:endParaRPr kumimoji="1" lang="ja-JP" altLang="en-US" sz="1100" dirty="0"/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38134A19-A103-4024-82EE-A3C5C485C072}"/>
              </a:ext>
            </a:extLst>
          </p:cNvPr>
          <p:cNvSpPr txBox="1"/>
          <p:nvPr/>
        </p:nvSpPr>
        <p:spPr>
          <a:xfrm>
            <a:off x="2071845" y="3199530"/>
            <a:ext cx="5712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000</a:t>
            </a:r>
            <a:endParaRPr kumimoji="1" lang="ja-JP" altLang="en-US" sz="1100" dirty="0"/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9C6B6F44-2E4F-44C5-801F-7C00756A3910}"/>
              </a:ext>
            </a:extLst>
          </p:cNvPr>
          <p:cNvSpPr txBox="1"/>
          <p:nvPr/>
        </p:nvSpPr>
        <p:spPr>
          <a:xfrm>
            <a:off x="2707402" y="3199530"/>
            <a:ext cx="5712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500</a:t>
            </a:r>
            <a:endParaRPr kumimoji="1" lang="ja-JP" altLang="en-US" sz="11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7FF014F-1647-4A80-AD82-89FC640479F6}"/>
              </a:ext>
            </a:extLst>
          </p:cNvPr>
          <p:cNvSpPr txBox="1"/>
          <p:nvPr/>
        </p:nvSpPr>
        <p:spPr>
          <a:xfrm>
            <a:off x="2657338" y="975461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Stage 0</a:t>
            </a:r>
            <a:endParaRPr kumimoji="1" lang="ja-JP" altLang="en-US" sz="11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D547CD0-1E54-4B19-84A0-671FB85970BC}"/>
              </a:ext>
            </a:extLst>
          </p:cNvPr>
          <p:cNvSpPr txBox="1"/>
          <p:nvPr/>
        </p:nvSpPr>
        <p:spPr>
          <a:xfrm>
            <a:off x="2639775" y="1333157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/>
              <a:t>P</a:t>
            </a:r>
            <a:r>
              <a:rPr kumimoji="1" lang="en-US" altLang="ja-JP" sz="1100" dirty="0"/>
              <a:t>=1.000</a:t>
            </a:r>
            <a:endParaRPr kumimoji="1" lang="ja-JP" altLang="en-US" sz="1100" dirty="0"/>
          </a:p>
        </p:txBody>
      </p: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FEF61E1A-6A33-41AD-AB40-A93E7250140E}"/>
              </a:ext>
            </a:extLst>
          </p:cNvPr>
          <p:cNvGrpSpPr/>
          <p:nvPr/>
        </p:nvGrpSpPr>
        <p:grpSpPr>
          <a:xfrm>
            <a:off x="3766561" y="1107345"/>
            <a:ext cx="2768065" cy="2402831"/>
            <a:chOff x="3570378" y="756469"/>
            <a:chExt cx="3106257" cy="2696400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BD030F9B-4EBE-42C9-BEFF-11F4934728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71932" y="756469"/>
              <a:ext cx="3004703" cy="2696400"/>
            </a:xfrm>
            <a:prstGeom prst="rect">
              <a:avLst/>
            </a:prstGeom>
          </p:spPr>
        </p:pic>
        <p:sp>
          <p:nvSpPr>
            <p:cNvPr id="140" name="正方形/長方形 139">
              <a:extLst>
                <a:ext uri="{FF2B5EF4-FFF2-40B4-BE49-F238E27FC236}">
                  <a16:creationId xmlns:a16="http://schemas.microsoft.com/office/drawing/2014/main" id="{82B03DC8-F63D-4426-B47A-B40ED80B10B8}"/>
                </a:ext>
              </a:extLst>
            </p:cNvPr>
            <p:cNvSpPr/>
            <p:nvPr/>
          </p:nvSpPr>
          <p:spPr>
            <a:xfrm>
              <a:off x="3980165" y="3055569"/>
              <a:ext cx="2642437" cy="3515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8A590881-81D3-4866-91A5-42E0176FF60F}"/>
                </a:ext>
              </a:extLst>
            </p:cNvPr>
            <p:cNvSpPr/>
            <p:nvPr/>
          </p:nvSpPr>
          <p:spPr>
            <a:xfrm>
              <a:off x="3570378" y="774758"/>
              <a:ext cx="449708" cy="2355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E1888068-5C7F-48F9-89D6-FA2526703E9A}"/>
              </a:ext>
            </a:extLst>
          </p:cNvPr>
          <p:cNvGrpSpPr/>
          <p:nvPr/>
        </p:nvGrpSpPr>
        <p:grpSpPr>
          <a:xfrm>
            <a:off x="4100926" y="1165542"/>
            <a:ext cx="2363362" cy="2064814"/>
            <a:chOff x="569170" y="3753969"/>
            <a:chExt cx="2652109" cy="2317085"/>
          </a:xfrm>
        </p:grpSpPr>
        <p:sp>
          <p:nvSpPr>
            <p:cNvPr id="111" name="正方形/長方形 1">
              <a:extLst>
                <a:ext uri="{FF2B5EF4-FFF2-40B4-BE49-F238E27FC236}">
                  <a16:creationId xmlns:a16="http://schemas.microsoft.com/office/drawing/2014/main" id="{C23F2247-CC5C-4268-B7CD-9CD20F824701}"/>
                </a:ext>
              </a:extLst>
            </p:cNvPr>
            <p:cNvSpPr/>
            <p:nvPr/>
          </p:nvSpPr>
          <p:spPr>
            <a:xfrm>
              <a:off x="622079" y="3753969"/>
              <a:ext cx="2599200" cy="2268000"/>
            </a:xfrm>
            <a:custGeom>
              <a:avLst/>
              <a:gdLst>
                <a:gd name="connsiteX0" fmla="*/ 0 w 2324025"/>
                <a:gd name="connsiteY0" fmla="*/ 0 h 2018243"/>
                <a:gd name="connsiteX1" fmla="*/ 2324025 w 2324025"/>
                <a:gd name="connsiteY1" fmla="*/ 0 h 2018243"/>
                <a:gd name="connsiteX2" fmla="*/ 2324025 w 2324025"/>
                <a:gd name="connsiteY2" fmla="*/ 2018243 h 2018243"/>
                <a:gd name="connsiteX3" fmla="*/ 0 w 2324025"/>
                <a:gd name="connsiteY3" fmla="*/ 2018243 h 2018243"/>
                <a:gd name="connsiteX4" fmla="*/ 0 w 2324025"/>
                <a:gd name="connsiteY4" fmla="*/ 0 h 2018243"/>
                <a:gd name="connsiteX0" fmla="*/ 0 w 2324025"/>
                <a:gd name="connsiteY0" fmla="*/ 0 h 2018243"/>
                <a:gd name="connsiteX1" fmla="*/ 2324025 w 2324025"/>
                <a:gd name="connsiteY1" fmla="*/ 2018243 h 2018243"/>
                <a:gd name="connsiteX2" fmla="*/ 0 w 2324025"/>
                <a:gd name="connsiteY2" fmla="*/ 2018243 h 2018243"/>
                <a:gd name="connsiteX3" fmla="*/ 0 w 2324025"/>
                <a:gd name="connsiteY3" fmla="*/ 0 h 2018243"/>
                <a:gd name="connsiteX0" fmla="*/ 2324025 w 2415465"/>
                <a:gd name="connsiteY0" fmla="*/ 2018243 h 2109683"/>
                <a:gd name="connsiteX1" fmla="*/ 0 w 2415465"/>
                <a:gd name="connsiteY1" fmla="*/ 2018243 h 2109683"/>
                <a:gd name="connsiteX2" fmla="*/ 0 w 2415465"/>
                <a:gd name="connsiteY2" fmla="*/ 0 h 2109683"/>
                <a:gd name="connsiteX3" fmla="*/ 2415465 w 2415465"/>
                <a:gd name="connsiteY3" fmla="*/ 2109683 h 2109683"/>
                <a:gd name="connsiteX0" fmla="*/ 2324025 w 2324025"/>
                <a:gd name="connsiteY0" fmla="*/ 2018243 h 2018243"/>
                <a:gd name="connsiteX1" fmla="*/ 0 w 2324025"/>
                <a:gd name="connsiteY1" fmla="*/ 2018243 h 2018243"/>
                <a:gd name="connsiteX2" fmla="*/ 0 w 2324025"/>
                <a:gd name="connsiteY2" fmla="*/ 0 h 20182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24025" h="2018243">
                  <a:moveTo>
                    <a:pt x="2324025" y="2018243"/>
                  </a:moveTo>
                  <a:lnTo>
                    <a:pt x="0" y="201824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27272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12" name="グループ化 111">
              <a:extLst>
                <a:ext uri="{FF2B5EF4-FFF2-40B4-BE49-F238E27FC236}">
                  <a16:creationId xmlns:a16="http://schemas.microsoft.com/office/drawing/2014/main" id="{09AA9B18-27EA-4462-B7B9-3476E42522B6}"/>
                </a:ext>
              </a:extLst>
            </p:cNvPr>
            <p:cNvGrpSpPr/>
            <p:nvPr/>
          </p:nvGrpSpPr>
          <p:grpSpPr>
            <a:xfrm>
              <a:off x="569170" y="3846102"/>
              <a:ext cx="54000" cy="2090986"/>
              <a:chOff x="569170" y="3846102"/>
              <a:chExt cx="54000" cy="2090986"/>
            </a:xfrm>
          </p:grpSpPr>
          <p:cxnSp>
            <p:nvCxnSpPr>
              <p:cNvPr id="118" name="直線コネクタ 117">
                <a:extLst>
                  <a:ext uri="{FF2B5EF4-FFF2-40B4-BE49-F238E27FC236}">
                    <a16:creationId xmlns:a16="http://schemas.microsoft.com/office/drawing/2014/main" id="{CE56CF01-E95F-4350-A69B-01780D30FE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3846102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線コネクタ 118">
                <a:extLst>
                  <a:ext uri="{FF2B5EF4-FFF2-40B4-BE49-F238E27FC236}">
                    <a16:creationId xmlns:a16="http://schemas.microsoft.com/office/drawing/2014/main" id="{104C29F8-1A43-4523-BA78-8831AA09BF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264299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線コネクタ 119">
                <a:extLst>
                  <a:ext uri="{FF2B5EF4-FFF2-40B4-BE49-F238E27FC236}">
                    <a16:creationId xmlns:a16="http://schemas.microsoft.com/office/drawing/2014/main" id="{C9FF36B5-F377-4A02-B526-A87820FEEF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682496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線コネクタ 120">
                <a:extLst>
                  <a:ext uri="{FF2B5EF4-FFF2-40B4-BE49-F238E27FC236}">
                    <a16:creationId xmlns:a16="http://schemas.microsoft.com/office/drawing/2014/main" id="{A9097323-05BC-4B9E-BE70-AA09A20736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100693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線コネクタ 121">
                <a:extLst>
                  <a:ext uri="{FF2B5EF4-FFF2-40B4-BE49-F238E27FC236}">
                    <a16:creationId xmlns:a16="http://schemas.microsoft.com/office/drawing/2014/main" id="{6425F06D-75AF-4649-BA5F-1386B7FB19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518890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線コネクタ 122">
                <a:extLst>
                  <a:ext uri="{FF2B5EF4-FFF2-40B4-BE49-F238E27FC236}">
                    <a16:creationId xmlns:a16="http://schemas.microsoft.com/office/drawing/2014/main" id="{299F841E-BDBE-450F-9C3E-2E101CB06F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937088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E70C23AD-CB87-4802-958B-015BDEDD0BF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7722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A4E6C0F9-39B9-4F80-8019-4AC13A03DF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10398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3B2D0FD0-BF83-469F-A83B-BB95779EA0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03074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F277AF55-D5EC-463C-A3E6-B2FA687224B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95750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DA53D600-72F6-4769-9215-DB3C44A588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88426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2C4FEE3-DE20-40D3-B560-CE0F20AC4978}"/>
              </a:ext>
            </a:extLst>
          </p:cNvPr>
          <p:cNvSpPr txBox="1"/>
          <p:nvPr/>
        </p:nvSpPr>
        <p:spPr>
          <a:xfrm>
            <a:off x="5859038" y="1077899"/>
            <a:ext cx="577402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Stage I</a:t>
            </a:r>
            <a:endParaRPr kumimoji="1" lang="ja-JP" altLang="en-US" sz="1100" b="1" dirty="0"/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F271C5D1-51D4-4033-8178-826593826AE7}"/>
              </a:ext>
            </a:extLst>
          </p:cNvPr>
          <p:cNvSpPr txBox="1"/>
          <p:nvPr/>
        </p:nvSpPr>
        <p:spPr>
          <a:xfrm>
            <a:off x="3777462" y="2967798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0</a:t>
            </a:r>
            <a:endParaRPr kumimoji="1" lang="ja-JP" altLang="en-US" sz="1100" dirty="0"/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B0D1E6CE-FA31-4E34-8CA7-1D5C64A634AC}"/>
              </a:ext>
            </a:extLst>
          </p:cNvPr>
          <p:cNvSpPr txBox="1"/>
          <p:nvPr/>
        </p:nvSpPr>
        <p:spPr>
          <a:xfrm>
            <a:off x="3777462" y="2596505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2</a:t>
            </a:r>
            <a:endParaRPr kumimoji="1" lang="ja-JP" altLang="en-US" sz="1100" dirty="0"/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A9092CF4-68A2-4C44-81E0-C4F6F25571B9}"/>
              </a:ext>
            </a:extLst>
          </p:cNvPr>
          <p:cNvSpPr txBox="1"/>
          <p:nvPr/>
        </p:nvSpPr>
        <p:spPr>
          <a:xfrm>
            <a:off x="3777462" y="222521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4</a:t>
            </a:r>
            <a:endParaRPr kumimoji="1" lang="ja-JP" altLang="en-US" sz="1100" dirty="0"/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431D4656-EF6E-4212-BC1A-47003E7135FE}"/>
              </a:ext>
            </a:extLst>
          </p:cNvPr>
          <p:cNvSpPr txBox="1"/>
          <p:nvPr/>
        </p:nvSpPr>
        <p:spPr>
          <a:xfrm>
            <a:off x="3777462" y="1853921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6</a:t>
            </a:r>
            <a:endParaRPr kumimoji="1" lang="ja-JP" altLang="en-US" sz="1100" dirty="0"/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7E9D128D-B051-4C30-A26B-A9BF2DE9B3E8}"/>
              </a:ext>
            </a:extLst>
          </p:cNvPr>
          <p:cNvSpPr txBox="1"/>
          <p:nvPr/>
        </p:nvSpPr>
        <p:spPr>
          <a:xfrm>
            <a:off x="3777462" y="1482629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8</a:t>
            </a:r>
            <a:endParaRPr kumimoji="1" lang="ja-JP" altLang="en-US" sz="1100" dirty="0"/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79C97FBA-8391-4F74-8AF7-C9452732A20A}"/>
              </a:ext>
            </a:extLst>
          </p:cNvPr>
          <p:cNvSpPr txBox="1"/>
          <p:nvPr/>
        </p:nvSpPr>
        <p:spPr>
          <a:xfrm>
            <a:off x="3777462" y="111133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.0</a:t>
            </a:r>
            <a:endParaRPr kumimoji="1" lang="ja-JP" altLang="en-US" sz="1100" dirty="0"/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0F8349BE-ECA9-4CFD-B6BB-323E2F38BB3F}"/>
              </a:ext>
            </a:extLst>
          </p:cNvPr>
          <p:cNvSpPr txBox="1"/>
          <p:nvPr/>
        </p:nvSpPr>
        <p:spPr>
          <a:xfrm>
            <a:off x="4105661" y="3199530"/>
            <a:ext cx="2656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</a:t>
            </a:r>
            <a:endParaRPr kumimoji="1" lang="ja-JP" altLang="en-US" sz="1100" dirty="0"/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1E0A0BB9-8012-42C4-A12F-C2F558859196}"/>
              </a:ext>
            </a:extLst>
          </p:cNvPr>
          <p:cNvSpPr txBox="1"/>
          <p:nvPr/>
        </p:nvSpPr>
        <p:spPr>
          <a:xfrm>
            <a:off x="4550224" y="3199530"/>
            <a:ext cx="414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500</a:t>
            </a:r>
            <a:endParaRPr kumimoji="1" lang="ja-JP" altLang="en-US" sz="1100" dirty="0"/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C85F6A6C-335A-41D3-97C1-55157AC00502}"/>
              </a:ext>
            </a:extLst>
          </p:cNvPr>
          <p:cNvSpPr txBox="1"/>
          <p:nvPr/>
        </p:nvSpPr>
        <p:spPr>
          <a:xfrm>
            <a:off x="5045851" y="3199530"/>
            <a:ext cx="489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000</a:t>
            </a:r>
            <a:endParaRPr kumimoji="1" lang="ja-JP" altLang="en-US" sz="1100" dirty="0"/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08C39B67-E313-41D6-B336-5C34E6880809}"/>
              </a:ext>
            </a:extLst>
          </p:cNvPr>
          <p:cNvSpPr txBox="1"/>
          <p:nvPr/>
        </p:nvSpPr>
        <p:spPr>
          <a:xfrm>
            <a:off x="5590487" y="3199530"/>
            <a:ext cx="489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500</a:t>
            </a:r>
            <a:endParaRPr kumimoji="1" lang="ja-JP" altLang="en-US" sz="1100" dirty="0"/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F9DAF5D0-53D5-4600-88F4-8C2F4462C000}"/>
              </a:ext>
            </a:extLst>
          </p:cNvPr>
          <p:cNvSpPr txBox="1"/>
          <p:nvPr/>
        </p:nvSpPr>
        <p:spPr>
          <a:xfrm>
            <a:off x="6100090" y="3199530"/>
            <a:ext cx="489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2000</a:t>
            </a:r>
            <a:endParaRPr kumimoji="1" lang="ja-JP" altLang="en-US" sz="11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A574398-61FA-4D08-AA58-265A7B852306}"/>
              </a:ext>
            </a:extLst>
          </p:cNvPr>
          <p:cNvSpPr txBox="1"/>
          <p:nvPr/>
        </p:nvSpPr>
        <p:spPr>
          <a:xfrm>
            <a:off x="5768331" y="1770394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/>
              <a:t>P</a:t>
            </a:r>
            <a:r>
              <a:rPr kumimoji="1" lang="en-US" altLang="ja-JP" sz="1100" dirty="0"/>
              <a:t>=0.418</a:t>
            </a:r>
            <a:endParaRPr kumimoji="1" lang="ja-JP" altLang="en-US" sz="1100" dirty="0"/>
          </a:p>
        </p:txBody>
      </p:sp>
      <p:grpSp>
        <p:nvGrpSpPr>
          <p:cNvPr id="152" name="グループ化 151">
            <a:extLst>
              <a:ext uri="{FF2B5EF4-FFF2-40B4-BE49-F238E27FC236}">
                <a16:creationId xmlns:a16="http://schemas.microsoft.com/office/drawing/2014/main" id="{12FF0C27-CD3E-4D36-821B-AB2633DBA88E}"/>
              </a:ext>
            </a:extLst>
          </p:cNvPr>
          <p:cNvGrpSpPr/>
          <p:nvPr/>
        </p:nvGrpSpPr>
        <p:grpSpPr>
          <a:xfrm>
            <a:off x="635550" y="6292607"/>
            <a:ext cx="2746956" cy="2377166"/>
            <a:chOff x="265935" y="6822153"/>
            <a:chExt cx="3082568" cy="2667600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883FF17D-6B3E-4561-AEF8-F9EAA1615BF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5734" y="6822153"/>
              <a:ext cx="2982769" cy="2667600"/>
            </a:xfrm>
            <a:prstGeom prst="rect">
              <a:avLst/>
            </a:prstGeom>
          </p:spPr>
        </p:pic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AD614A99-202B-48FF-A69F-648EEBD1EC62}"/>
                </a:ext>
              </a:extLst>
            </p:cNvPr>
            <p:cNvSpPr/>
            <p:nvPr/>
          </p:nvSpPr>
          <p:spPr>
            <a:xfrm>
              <a:off x="691364" y="9127792"/>
              <a:ext cx="2642437" cy="3515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7" name="正方形/長方形 146">
              <a:extLst>
                <a:ext uri="{FF2B5EF4-FFF2-40B4-BE49-F238E27FC236}">
                  <a16:creationId xmlns:a16="http://schemas.microsoft.com/office/drawing/2014/main" id="{38C4C32F-2641-4FE7-9DEC-68B737B02C68}"/>
                </a:ext>
              </a:extLst>
            </p:cNvPr>
            <p:cNvSpPr/>
            <p:nvPr/>
          </p:nvSpPr>
          <p:spPr>
            <a:xfrm>
              <a:off x="265935" y="6837047"/>
              <a:ext cx="449708" cy="2355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87A0EE7A-BE60-4C31-AA88-E48DCF2E47E8}"/>
              </a:ext>
            </a:extLst>
          </p:cNvPr>
          <p:cNvGrpSpPr/>
          <p:nvPr/>
        </p:nvGrpSpPr>
        <p:grpSpPr>
          <a:xfrm>
            <a:off x="973368" y="6333525"/>
            <a:ext cx="2363363" cy="2064813"/>
            <a:chOff x="569170" y="3753969"/>
            <a:chExt cx="2652109" cy="2317085"/>
          </a:xfrm>
        </p:grpSpPr>
        <p:sp>
          <p:nvSpPr>
            <p:cNvPr id="96" name="正方形/長方形 1">
              <a:extLst>
                <a:ext uri="{FF2B5EF4-FFF2-40B4-BE49-F238E27FC236}">
                  <a16:creationId xmlns:a16="http://schemas.microsoft.com/office/drawing/2014/main" id="{470482F2-6287-4D36-A8A2-6EA97BEA4F72}"/>
                </a:ext>
              </a:extLst>
            </p:cNvPr>
            <p:cNvSpPr/>
            <p:nvPr/>
          </p:nvSpPr>
          <p:spPr>
            <a:xfrm>
              <a:off x="622079" y="3753969"/>
              <a:ext cx="2599200" cy="2268000"/>
            </a:xfrm>
            <a:custGeom>
              <a:avLst/>
              <a:gdLst>
                <a:gd name="connsiteX0" fmla="*/ 0 w 2324025"/>
                <a:gd name="connsiteY0" fmla="*/ 0 h 2018243"/>
                <a:gd name="connsiteX1" fmla="*/ 2324025 w 2324025"/>
                <a:gd name="connsiteY1" fmla="*/ 0 h 2018243"/>
                <a:gd name="connsiteX2" fmla="*/ 2324025 w 2324025"/>
                <a:gd name="connsiteY2" fmla="*/ 2018243 h 2018243"/>
                <a:gd name="connsiteX3" fmla="*/ 0 w 2324025"/>
                <a:gd name="connsiteY3" fmla="*/ 2018243 h 2018243"/>
                <a:gd name="connsiteX4" fmla="*/ 0 w 2324025"/>
                <a:gd name="connsiteY4" fmla="*/ 0 h 2018243"/>
                <a:gd name="connsiteX0" fmla="*/ 0 w 2324025"/>
                <a:gd name="connsiteY0" fmla="*/ 0 h 2018243"/>
                <a:gd name="connsiteX1" fmla="*/ 2324025 w 2324025"/>
                <a:gd name="connsiteY1" fmla="*/ 2018243 h 2018243"/>
                <a:gd name="connsiteX2" fmla="*/ 0 w 2324025"/>
                <a:gd name="connsiteY2" fmla="*/ 2018243 h 2018243"/>
                <a:gd name="connsiteX3" fmla="*/ 0 w 2324025"/>
                <a:gd name="connsiteY3" fmla="*/ 0 h 2018243"/>
                <a:gd name="connsiteX0" fmla="*/ 2324025 w 2415465"/>
                <a:gd name="connsiteY0" fmla="*/ 2018243 h 2109683"/>
                <a:gd name="connsiteX1" fmla="*/ 0 w 2415465"/>
                <a:gd name="connsiteY1" fmla="*/ 2018243 h 2109683"/>
                <a:gd name="connsiteX2" fmla="*/ 0 w 2415465"/>
                <a:gd name="connsiteY2" fmla="*/ 0 h 2109683"/>
                <a:gd name="connsiteX3" fmla="*/ 2415465 w 2415465"/>
                <a:gd name="connsiteY3" fmla="*/ 2109683 h 2109683"/>
                <a:gd name="connsiteX0" fmla="*/ 2324025 w 2324025"/>
                <a:gd name="connsiteY0" fmla="*/ 2018243 h 2018243"/>
                <a:gd name="connsiteX1" fmla="*/ 0 w 2324025"/>
                <a:gd name="connsiteY1" fmla="*/ 2018243 h 2018243"/>
                <a:gd name="connsiteX2" fmla="*/ 0 w 2324025"/>
                <a:gd name="connsiteY2" fmla="*/ 0 h 20182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24025" h="2018243">
                  <a:moveTo>
                    <a:pt x="2324025" y="2018243"/>
                  </a:moveTo>
                  <a:lnTo>
                    <a:pt x="0" y="201824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27272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56E864EF-4FEB-4377-BCDF-2DD0FFEC3B64}"/>
                </a:ext>
              </a:extLst>
            </p:cNvPr>
            <p:cNvGrpSpPr/>
            <p:nvPr/>
          </p:nvGrpSpPr>
          <p:grpSpPr>
            <a:xfrm>
              <a:off x="569170" y="3846102"/>
              <a:ext cx="54000" cy="2090986"/>
              <a:chOff x="569170" y="3846102"/>
              <a:chExt cx="54000" cy="2090986"/>
            </a:xfrm>
          </p:grpSpPr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id="{AD7A17D4-780D-4A7D-934E-BFC3DD9E7D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3846102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id="{ACB347F8-E586-48E4-B4F3-5C10CB955F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264299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線コネクタ 104">
                <a:extLst>
                  <a:ext uri="{FF2B5EF4-FFF2-40B4-BE49-F238E27FC236}">
                    <a16:creationId xmlns:a16="http://schemas.microsoft.com/office/drawing/2014/main" id="{023EB20F-E0EC-4661-BEA6-69B1EEC7BE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682496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線コネクタ 105">
                <a:extLst>
                  <a:ext uri="{FF2B5EF4-FFF2-40B4-BE49-F238E27FC236}">
                    <a16:creationId xmlns:a16="http://schemas.microsoft.com/office/drawing/2014/main" id="{ABCFC264-6E0D-43BE-9D70-54CEA44D58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100693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線コネクタ 106">
                <a:extLst>
                  <a:ext uri="{FF2B5EF4-FFF2-40B4-BE49-F238E27FC236}">
                    <a16:creationId xmlns:a16="http://schemas.microsoft.com/office/drawing/2014/main" id="{885E4097-8FC4-4B0E-9334-3CC388D373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518890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線コネクタ 107">
                <a:extLst>
                  <a:ext uri="{FF2B5EF4-FFF2-40B4-BE49-F238E27FC236}">
                    <a16:creationId xmlns:a16="http://schemas.microsoft.com/office/drawing/2014/main" id="{E0BAB220-A19F-464A-959B-E017FC01E5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937088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12F58097-9EDA-44FB-A423-D3C688CADD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7722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BCDFAE99-49DE-4E2F-B36E-B47B79BC3FD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90293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5115419C-9DCC-43F5-847F-6E2A0A6BAA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62864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3980D75D-DA14-4A08-A0D8-8A5CC1AA44F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35435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51F80D75-D378-4F31-93B2-DD107774E9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08005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F3AEA46-C8EB-40D1-BE18-B72FBA5C253F}"/>
              </a:ext>
            </a:extLst>
          </p:cNvPr>
          <p:cNvSpPr txBox="1"/>
          <p:nvPr/>
        </p:nvSpPr>
        <p:spPr>
          <a:xfrm>
            <a:off x="980440" y="8374777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</a:t>
            </a:r>
            <a:endParaRPr kumimoji="1" lang="ja-JP" altLang="en-US" sz="11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D5054DB-C90A-44F2-B21F-606FB22E2CBC}"/>
              </a:ext>
            </a:extLst>
          </p:cNvPr>
          <p:cNvSpPr txBox="1"/>
          <p:nvPr/>
        </p:nvSpPr>
        <p:spPr>
          <a:xfrm>
            <a:off x="1410143" y="8374777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500</a:t>
            </a:r>
            <a:endParaRPr kumimoji="1" lang="ja-JP" altLang="en-US" sz="11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4B07745-01F9-4BEB-9A1E-9F10402B2CC4}"/>
              </a:ext>
            </a:extLst>
          </p:cNvPr>
          <p:cNvSpPr txBox="1"/>
          <p:nvPr/>
        </p:nvSpPr>
        <p:spPr>
          <a:xfrm>
            <a:off x="1889202" y="8374777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000</a:t>
            </a:r>
            <a:endParaRPr kumimoji="1" lang="ja-JP" altLang="en-US" sz="11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84300B9-BF27-4063-BDFA-BA717D05AB77}"/>
              </a:ext>
            </a:extLst>
          </p:cNvPr>
          <p:cNvSpPr txBox="1"/>
          <p:nvPr/>
        </p:nvSpPr>
        <p:spPr>
          <a:xfrm>
            <a:off x="2415633" y="8374777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500</a:t>
            </a:r>
            <a:endParaRPr kumimoji="1" lang="ja-JP" altLang="en-US" sz="11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44BAEE7-23F8-4296-B16E-B942322260D1}"/>
              </a:ext>
            </a:extLst>
          </p:cNvPr>
          <p:cNvSpPr txBox="1"/>
          <p:nvPr/>
        </p:nvSpPr>
        <p:spPr>
          <a:xfrm>
            <a:off x="2908201" y="8374777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2000</a:t>
            </a:r>
            <a:endParaRPr kumimoji="1" lang="ja-JP" altLang="en-US" sz="11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50E2925-D5AC-40DA-A0EF-3B6856D5D9D2}"/>
              </a:ext>
            </a:extLst>
          </p:cNvPr>
          <p:cNvSpPr txBox="1"/>
          <p:nvPr/>
        </p:nvSpPr>
        <p:spPr>
          <a:xfrm>
            <a:off x="660254" y="8134490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0</a:t>
            </a:r>
            <a:endParaRPr kumimoji="1" lang="ja-JP" altLang="en-US" sz="11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2339725-F074-490C-A7D0-8678FF8C8B3C}"/>
              </a:ext>
            </a:extLst>
          </p:cNvPr>
          <p:cNvSpPr txBox="1"/>
          <p:nvPr/>
        </p:nvSpPr>
        <p:spPr>
          <a:xfrm>
            <a:off x="660254" y="776319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2</a:t>
            </a:r>
            <a:endParaRPr kumimoji="1" lang="ja-JP" altLang="en-US" sz="11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3BA28A2-4180-4281-BDF5-0F7C69B72C65}"/>
              </a:ext>
            </a:extLst>
          </p:cNvPr>
          <p:cNvSpPr txBox="1"/>
          <p:nvPr/>
        </p:nvSpPr>
        <p:spPr>
          <a:xfrm>
            <a:off x="660254" y="7391905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4</a:t>
            </a:r>
            <a:endParaRPr kumimoji="1" lang="ja-JP" altLang="en-US" sz="11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448397C-41ED-4244-B908-B446EB9C6C5A}"/>
              </a:ext>
            </a:extLst>
          </p:cNvPr>
          <p:cNvSpPr txBox="1"/>
          <p:nvPr/>
        </p:nvSpPr>
        <p:spPr>
          <a:xfrm>
            <a:off x="660254" y="702061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6</a:t>
            </a:r>
            <a:endParaRPr kumimoji="1" lang="ja-JP" altLang="en-US" sz="11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F0541F7-C1E7-4FBD-B74F-779B2A36EBCF}"/>
              </a:ext>
            </a:extLst>
          </p:cNvPr>
          <p:cNvSpPr txBox="1"/>
          <p:nvPr/>
        </p:nvSpPr>
        <p:spPr>
          <a:xfrm>
            <a:off x="660254" y="6649321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8</a:t>
            </a:r>
            <a:endParaRPr kumimoji="1" lang="ja-JP" altLang="en-US" sz="11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87C77C0-CAC5-4089-B594-9F0C535BE3C4}"/>
              </a:ext>
            </a:extLst>
          </p:cNvPr>
          <p:cNvSpPr txBox="1"/>
          <p:nvPr/>
        </p:nvSpPr>
        <p:spPr>
          <a:xfrm>
            <a:off x="660254" y="6278029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.0</a:t>
            </a:r>
            <a:endParaRPr kumimoji="1" lang="ja-JP" altLang="en-US" sz="11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8181031-3E58-42AF-AC87-58E3EECE4883}"/>
              </a:ext>
            </a:extLst>
          </p:cNvPr>
          <p:cNvSpPr txBox="1"/>
          <p:nvPr/>
        </p:nvSpPr>
        <p:spPr>
          <a:xfrm>
            <a:off x="2632491" y="6432659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Stage IV</a:t>
            </a:r>
            <a:endParaRPr kumimoji="1" lang="ja-JP" altLang="en-US" sz="1100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2C12C8F-8673-4E15-8D12-03C504494442}"/>
              </a:ext>
            </a:extLst>
          </p:cNvPr>
          <p:cNvSpPr txBox="1"/>
          <p:nvPr/>
        </p:nvSpPr>
        <p:spPr>
          <a:xfrm>
            <a:off x="2631524" y="7756266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/>
              <a:t>P</a:t>
            </a:r>
            <a:r>
              <a:rPr kumimoji="1" lang="en-US" altLang="ja-JP" sz="1100" dirty="0"/>
              <a:t>=0.245</a:t>
            </a:r>
            <a:endParaRPr kumimoji="1" lang="ja-JP" altLang="en-US" sz="1100" dirty="0"/>
          </a:p>
        </p:txBody>
      </p: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86DE019D-7603-42AA-B0BD-A06AFFA01953}"/>
              </a:ext>
            </a:extLst>
          </p:cNvPr>
          <p:cNvGrpSpPr/>
          <p:nvPr/>
        </p:nvGrpSpPr>
        <p:grpSpPr>
          <a:xfrm>
            <a:off x="3766561" y="3720877"/>
            <a:ext cx="2761770" cy="2257299"/>
            <a:chOff x="3495868" y="3588855"/>
            <a:chExt cx="3099192" cy="2533086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E1F11CE8-B2DD-43BB-9E78-6AF144FDBC8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56078" y="3591140"/>
              <a:ext cx="3038982" cy="2530801"/>
            </a:xfrm>
            <a:prstGeom prst="rect">
              <a:avLst/>
            </a:prstGeom>
          </p:spPr>
        </p:pic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id="{A7D5CF80-C5C8-49A7-9BF1-FDBB2869B192}"/>
                </a:ext>
              </a:extLst>
            </p:cNvPr>
            <p:cNvSpPr/>
            <p:nvPr/>
          </p:nvSpPr>
          <p:spPr>
            <a:xfrm>
              <a:off x="3905655" y="5869667"/>
              <a:ext cx="2642437" cy="2341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56AD74B9-AF23-4531-A754-71394C7D2EBE}"/>
                </a:ext>
              </a:extLst>
            </p:cNvPr>
            <p:cNvSpPr/>
            <p:nvPr/>
          </p:nvSpPr>
          <p:spPr>
            <a:xfrm>
              <a:off x="3495868" y="3588855"/>
              <a:ext cx="449708" cy="23556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id="{2B683AB5-14F2-481A-8E94-447C61C97808}"/>
              </a:ext>
            </a:extLst>
          </p:cNvPr>
          <p:cNvGrpSpPr/>
          <p:nvPr/>
        </p:nvGrpSpPr>
        <p:grpSpPr>
          <a:xfrm>
            <a:off x="4097751" y="3751025"/>
            <a:ext cx="2363363" cy="2064815"/>
            <a:chOff x="569170" y="3753969"/>
            <a:chExt cx="2652109" cy="2317085"/>
          </a:xfrm>
        </p:grpSpPr>
        <p:sp>
          <p:nvSpPr>
            <p:cNvPr id="125" name="正方形/長方形 1">
              <a:extLst>
                <a:ext uri="{FF2B5EF4-FFF2-40B4-BE49-F238E27FC236}">
                  <a16:creationId xmlns:a16="http://schemas.microsoft.com/office/drawing/2014/main" id="{301040AB-E58B-41D8-966F-08C8A365E67A}"/>
                </a:ext>
              </a:extLst>
            </p:cNvPr>
            <p:cNvSpPr/>
            <p:nvPr/>
          </p:nvSpPr>
          <p:spPr>
            <a:xfrm>
              <a:off x="622079" y="3753969"/>
              <a:ext cx="2599200" cy="2268000"/>
            </a:xfrm>
            <a:custGeom>
              <a:avLst/>
              <a:gdLst>
                <a:gd name="connsiteX0" fmla="*/ 0 w 2324025"/>
                <a:gd name="connsiteY0" fmla="*/ 0 h 2018243"/>
                <a:gd name="connsiteX1" fmla="*/ 2324025 w 2324025"/>
                <a:gd name="connsiteY1" fmla="*/ 0 h 2018243"/>
                <a:gd name="connsiteX2" fmla="*/ 2324025 w 2324025"/>
                <a:gd name="connsiteY2" fmla="*/ 2018243 h 2018243"/>
                <a:gd name="connsiteX3" fmla="*/ 0 w 2324025"/>
                <a:gd name="connsiteY3" fmla="*/ 2018243 h 2018243"/>
                <a:gd name="connsiteX4" fmla="*/ 0 w 2324025"/>
                <a:gd name="connsiteY4" fmla="*/ 0 h 2018243"/>
                <a:gd name="connsiteX0" fmla="*/ 0 w 2324025"/>
                <a:gd name="connsiteY0" fmla="*/ 0 h 2018243"/>
                <a:gd name="connsiteX1" fmla="*/ 2324025 w 2324025"/>
                <a:gd name="connsiteY1" fmla="*/ 2018243 h 2018243"/>
                <a:gd name="connsiteX2" fmla="*/ 0 w 2324025"/>
                <a:gd name="connsiteY2" fmla="*/ 2018243 h 2018243"/>
                <a:gd name="connsiteX3" fmla="*/ 0 w 2324025"/>
                <a:gd name="connsiteY3" fmla="*/ 0 h 2018243"/>
                <a:gd name="connsiteX0" fmla="*/ 2324025 w 2415465"/>
                <a:gd name="connsiteY0" fmla="*/ 2018243 h 2109683"/>
                <a:gd name="connsiteX1" fmla="*/ 0 w 2415465"/>
                <a:gd name="connsiteY1" fmla="*/ 2018243 h 2109683"/>
                <a:gd name="connsiteX2" fmla="*/ 0 w 2415465"/>
                <a:gd name="connsiteY2" fmla="*/ 0 h 2109683"/>
                <a:gd name="connsiteX3" fmla="*/ 2415465 w 2415465"/>
                <a:gd name="connsiteY3" fmla="*/ 2109683 h 2109683"/>
                <a:gd name="connsiteX0" fmla="*/ 2324025 w 2324025"/>
                <a:gd name="connsiteY0" fmla="*/ 2018243 h 2018243"/>
                <a:gd name="connsiteX1" fmla="*/ 0 w 2324025"/>
                <a:gd name="connsiteY1" fmla="*/ 2018243 h 2018243"/>
                <a:gd name="connsiteX2" fmla="*/ 0 w 2324025"/>
                <a:gd name="connsiteY2" fmla="*/ 0 h 20182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24025" h="2018243">
                  <a:moveTo>
                    <a:pt x="2324025" y="2018243"/>
                  </a:moveTo>
                  <a:lnTo>
                    <a:pt x="0" y="201824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27272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26" name="グループ化 125">
              <a:extLst>
                <a:ext uri="{FF2B5EF4-FFF2-40B4-BE49-F238E27FC236}">
                  <a16:creationId xmlns:a16="http://schemas.microsoft.com/office/drawing/2014/main" id="{19C990F9-2A37-428D-8BD0-EA42149E6FCC}"/>
                </a:ext>
              </a:extLst>
            </p:cNvPr>
            <p:cNvGrpSpPr/>
            <p:nvPr/>
          </p:nvGrpSpPr>
          <p:grpSpPr>
            <a:xfrm>
              <a:off x="569170" y="3846102"/>
              <a:ext cx="54000" cy="2090986"/>
              <a:chOff x="569170" y="3846102"/>
              <a:chExt cx="54000" cy="2090986"/>
            </a:xfrm>
          </p:grpSpPr>
          <p:cxnSp>
            <p:nvCxnSpPr>
              <p:cNvPr id="132" name="直線コネクタ 131">
                <a:extLst>
                  <a:ext uri="{FF2B5EF4-FFF2-40B4-BE49-F238E27FC236}">
                    <a16:creationId xmlns:a16="http://schemas.microsoft.com/office/drawing/2014/main" id="{3EE5E40C-6025-4093-8DB2-864446A819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3846102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線コネクタ 132">
                <a:extLst>
                  <a:ext uri="{FF2B5EF4-FFF2-40B4-BE49-F238E27FC236}">
                    <a16:creationId xmlns:a16="http://schemas.microsoft.com/office/drawing/2014/main" id="{68E03DD1-16F8-4236-B721-EDA6DACC65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264299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線コネクタ 133">
                <a:extLst>
                  <a:ext uri="{FF2B5EF4-FFF2-40B4-BE49-F238E27FC236}">
                    <a16:creationId xmlns:a16="http://schemas.microsoft.com/office/drawing/2014/main" id="{A309F8C8-9B2B-4C05-B6BA-0E2E9F02B2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4682496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線コネクタ 134">
                <a:extLst>
                  <a:ext uri="{FF2B5EF4-FFF2-40B4-BE49-F238E27FC236}">
                    <a16:creationId xmlns:a16="http://schemas.microsoft.com/office/drawing/2014/main" id="{DDDFABEE-E546-4B6E-9138-F2CCF90176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100693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線コネクタ 135">
                <a:extLst>
                  <a:ext uri="{FF2B5EF4-FFF2-40B4-BE49-F238E27FC236}">
                    <a16:creationId xmlns:a16="http://schemas.microsoft.com/office/drawing/2014/main" id="{04F81B83-E735-4061-854A-7530B86209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518890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直線コネクタ 136">
                <a:extLst>
                  <a:ext uri="{FF2B5EF4-FFF2-40B4-BE49-F238E27FC236}">
                    <a16:creationId xmlns:a16="http://schemas.microsoft.com/office/drawing/2014/main" id="{9A0A201A-6123-4F62-AD0D-8ADCA213AF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9170" y="5937088"/>
                <a:ext cx="54000" cy="0"/>
              </a:xfrm>
              <a:prstGeom prst="line">
                <a:avLst/>
              </a:prstGeom>
              <a:ln>
                <a:solidFill>
                  <a:srgbClr val="27272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751A2852-F285-4D85-B8CB-4F10710348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7722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E2C7F4EA-C76E-4899-9305-B066D6FB61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02293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DE54AA62-9B2D-4C5C-B5DE-5428630172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6864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B34FC555-56C9-498E-88A5-9080D65328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1435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コネクタ 130">
              <a:extLst>
                <a:ext uri="{FF2B5EF4-FFF2-40B4-BE49-F238E27FC236}">
                  <a16:creationId xmlns:a16="http://schemas.microsoft.com/office/drawing/2014/main" id="{B3F482E5-2781-46AE-A234-6C95D85F21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56006" y="6024254"/>
              <a:ext cx="0" cy="46800"/>
            </a:xfrm>
            <a:prstGeom prst="line">
              <a:avLst/>
            </a:prstGeom>
            <a:ln>
              <a:solidFill>
                <a:srgbClr val="2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91A936D6-8F3E-4DEA-9594-542DD50F0075}"/>
              </a:ext>
            </a:extLst>
          </p:cNvPr>
          <p:cNvSpPr txBox="1"/>
          <p:nvPr/>
        </p:nvSpPr>
        <p:spPr>
          <a:xfrm>
            <a:off x="3777462" y="5559546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0</a:t>
            </a:r>
            <a:endParaRPr kumimoji="1" lang="ja-JP" altLang="en-US" sz="1100" dirty="0"/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AD1F029E-DAB4-410D-B88F-4FA05E500BFC}"/>
              </a:ext>
            </a:extLst>
          </p:cNvPr>
          <p:cNvSpPr txBox="1"/>
          <p:nvPr/>
        </p:nvSpPr>
        <p:spPr>
          <a:xfrm>
            <a:off x="3777462" y="5188253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2</a:t>
            </a:r>
            <a:endParaRPr kumimoji="1" lang="ja-JP" altLang="en-US" sz="1100" dirty="0"/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6F8247EF-4751-4EBF-A8C9-03F317ACD3A7}"/>
              </a:ext>
            </a:extLst>
          </p:cNvPr>
          <p:cNvSpPr txBox="1"/>
          <p:nvPr/>
        </p:nvSpPr>
        <p:spPr>
          <a:xfrm>
            <a:off x="3777462" y="4816961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4</a:t>
            </a:r>
            <a:endParaRPr kumimoji="1" lang="ja-JP" altLang="en-US" sz="1100" dirty="0"/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CEB8DC6F-6323-499C-97A7-9F29E2F06415}"/>
              </a:ext>
            </a:extLst>
          </p:cNvPr>
          <p:cNvSpPr txBox="1"/>
          <p:nvPr/>
        </p:nvSpPr>
        <p:spPr>
          <a:xfrm>
            <a:off x="3777462" y="4445669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6</a:t>
            </a:r>
            <a:endParaRPr kumimoji="1" lang="ja-JP" altLang="en-US" sz="1100" dirty="0"/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CD8CB85C-EE48-4A63-B3AB-085DCC9FF264}"/>
              </a:ext>
            </a:extLst>
          </p:cNvPr>
          <p:cNvSpPr txBox="1"/>
          <p:nvPr/>
        </p:nvSpPr>
        <p:spPr>
          <a:xfrm>
            <a:off x="3777462" y="407437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.8</a:t>
            </a:r>
            <a:endParaRPr kumimoji="1" lang="ja-JP" altLang="en-US" sz="1100" dirty="0"/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851E8B1F-A4D0-46B0-B67E-2DAE0BFBEA4A}"/>
              </a:ext>
            </a:extLst>
          </p:cNvPr>
          <p:cNvSpPr txBox="1"/>
          <p:nvPr/>
        </p:nvSpPr>
        <p:spPr>
          <a:xfrm>
            <a:off x="3777462" y="3703085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.0</a:t>
            </a:r>
            <a:endParaRPr kumimoji="1" lang="ja-JP" altLang="en-US" sz="11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4AC8702-D152-4558-A22C-ED2994C9D159}"/>
              </a:ext>
            </a:extLst>
          </p:cNvPr>
          <p:cNvSpPr txBox="1"/>
          <p:nvPr/>
        </p:nvSpPr>
        <p:spPr>
          <a:xfrm>
            <a:off x="5785300" y="3541311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Stage III</a:t>
            </a:r>
            <a:endParaRPr kumimoji="1" lang="ja-JP" altLang="en-US" sz="11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B5A8BD5-E0CF-48A7-8008-967EADB846F3}"/>
              </a:ext>
            </a:extLst>
          </p:cNvPr>
          <p:cNvSpPr txBox="1"/>
          <p:nvPr/>
        </p:nvSpPr>
        <p:spPr>
          <a:xfrm>
            <a:off x="5785300" y="4188628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/>
              <a:t>P</a:t>
            </a:r>
            <a:r>
              <a:rPr kumimoji="1" lang="en-US" altLang="ja-JP" sz="1100" dirty="0"/>
              <a:t>=0.460</a:t>
            </a:r>
            <a:endParaRPr kumimoji="1" lang="ja-JP" altLang="en-US" sz="1100" dirty="0"/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460CFEDC-EFAB-4F81-9B9F-716D742EE3A0}"/>
              </a:ext>
            </a:extLst>
          </p:cNvPr>
          <p:cNvSpPr txBox="1"/>
          <p:nvPr/>
        </p:nvSpPr>
        <p:spPr>
          <a:xfrm>
            <a:off x="4113310" y="5798260"/>
            <a:ext cx="261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0</a:t>
            </a:r>
            <a:endParaRPr kumimoji="1" lang="ja-JP" altLang="en-US" sz="1100" dirty="0"/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516D8A9F-DCA3-43A0-944F-E3B8424B6E87}"/>
              </a:ext>
            </a:extLst>
          </p:cNvPr>
          <p:cNvSpPr txBox="1"/>
          <p:nvPr/>
        </p:nvSpPr>
        <p:spPr>
          <a:xfrm>
            <a:off x="4551431" y="5798260"/>
            <a:ext cx="4089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500</a:t>
            </a:r>
            <a:endParaRPr kumimoji="1" lang="ja-JP" altLang="en-US" sz="1100" dirty="0"/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7A4160F0-DE3F-448E-908D-CE861BE1960B}"/>
              </a:ext>
            </a:extLst>
          </p:cNvPr>
          <p:cNvSpPr txBox="1"/>
          <p:nvPr/>
        </p:nvSpPr>
        <p:spPr>
          <a:xfrm>
            <a:off x="5039874" y="5798260"/>
            <a:ext cx="4824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000</a:t>
            </a:r>
            <a:endParaRPr kumimoji="1" lang="ja-JP" altLang="en-US" sz="1100" dirty="0"/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FB356C12-AAAD-4803-B6DA-3D6CB2CB02DE}"/>
              </a:ext>
            </a:extLst>
          </p:cNvPr>
          <p:cNvSpPr txBox="1"/>
          <p:nvPr/>
        </p:nvSpPr>
        <p:spPr>
          <a:xfrm>
            <a:off x="5576617" y="5798260"/>
            <a:ext cx="4824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500</a:t>
            </a:r>
            <a:endParaRPr kumimoji="1" lang="ja-JP" altLang="en-US" sz="1100" dirty="0"/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E8CC616B-EF61-4594-9A66-6D83554936D0}"/>
              </a:ext>
            </a:extLst>
          </p:cNvPr>
          <p:cNvSpPr txBox="1"/>
          <p:nvPr/>
        </p:nvSpPr>
        <p:spPr>
          <a:xfrm>
            <a:off x="6078834" y="5798260"/>
            <a:ext cx="4824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2000</a:t>
            </a:r>
            <a:endParaRPr kumimoji="1" lang="ja-JP" altLang="en-US" sz="11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470EED-75C8-4D89-B3B7-5EC52D2053EE}"/>
              </a:ext>
            </a:extLst>
          </p:cNvPr>
          <p:cNvSpPr txBox="1"/>
          <p:nvPr/>
        </p:nvSpPr>
        <p:spPr>
          <a:xfrm>
            <a:off x="348078" y="3378773"/>
            <a:ext cx="498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c</a:t>
            </a:r>
            <a:endParaRPr kumimoji="1" lang="ja-JP" altLang="en-US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B3EE177-0E4D-4772-8C51-A407569A8BBF}"/>
              </a:ext>
            </a:extLst>
          </p:cNvPr>
          <p:cNvSpPr txBox="1"/>
          <p:nvPr/>
        </p:nvSpPr>
        <p:spPr>
          <a:xfrm>
            <a:off x="348078" y="5963333"/>
            <a:ext cx="498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e</a:t>
            </a:r>
            <a:endParaRPr kumimoji="1" lang="ja-JP" altLang="en-US" b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FC9DDDA-99AF-4FD9-A4F7-275AAA2EC788}"/>
              </a:ext>
            </a:extLst>
          </p:cNvPr>
          <p:cNvSpPr txBox="1"/>
          <p:nvPr/>
        </p:nvSpPr>
        <p:spPr>
          <a:xfrm>
            <a:off x="348078" y="794212"/>
            <a:ext cx="498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E96D2B9-8341-4A64-992C-E2490F4E184C}"/>
              </a:ext>
            </a:extLst>
          </p:cNvPr>
          <p:cNvSpPr txBox="1"/>
          <p:nvPr/>
        </p:nvSpPr>
        <p:spPr>
          <a:xfrm>
            <a:off x="3486485" y="3378773"/>
            <a:ext cx="498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D63F57B-8F2C-47A3-A35B-07FD371618FC}"/>
              </a:ext>
            </a:extLst>
          </p:cNvPr>
          <p:cNvSpPr txBox="1"/>
          <p:nvPr/>
        </p:nvSpPr>
        <p:spPr>
          <a:xfrm>
            <a:off x="3492365" y="794212"/>
            <a:ext cx="498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56602E0C-ACDE-41CA-8B0A-46C9641756D3}"/>
              </a:ext>
            </a:extLst>
          </p:cNvPr>
          <p:cNvSpPr txBox="1"/>
          <p:nvPr/>
        </p:nvSpPr>
        <p:spPr>
          <a:xfrm>
            <a:off x="4643541" y="6075604"/>
            <a:ext cx="135485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urvival time in days</a:t>
            </a:r>
            <a:endParaRPr kumimoji="1" lang="ja-JP" altLang="en-US" sz="1100" dirty="0"/>
          </a:p>
        </p:txBody>
      </p: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A7571C93-9E08-448C-AEB3-81EEEA34918C}"/>
              </a:ext>
            </a:extLst>
          </p:cNvPr>
          <p:cNvSpPr txBox="1"/>
          <p:nvPr/>
        </p:nvSpPr>
        <p:spPr>
          <a:xfrm rot="16200000">
            <a:off x="-48078" y="4486225"/>
            <a:ext cx="128272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urvival probability</a:t>
            </a:r>
            <a:endParaRPr kumimoji="1" lang="ja-JP" altLang="en-US" sz="1100" dirty="0"/>
          </a:p>
        </p:txBody>
      </p:sp>
      <p:sp>
        <p:nvSpPr>
          <p:cNvPr id="274" name="正方形/長方形 273">
            <a:extLst>
              <a:ext uri="{FF2B5EF4-FFF2-40B4-BE49-F238E27FC236}">
                <a16:creationId xmlns:a16="http://schemas.microsoft.com/office/drawing/2014/main" id="{657B28AF-6793-4C5C-8B8F-B36693238613}"/>
              </a:ext>
            </a:extLst>
          </p:cNvPr>
          <p:cNvSpPr/>
          <p:nvPr/>
        </p:nvSpPr>
        <p:spPr>
          <a:xfrm>
            <a:off x="5039874" y="5406792"/>
            <a:ext cx="639129" cy="309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6E9E0062-4F73-4DC9-A834-652595633DAF}"/>
              </a:ext>
            </a:extLst>
          </p:cNvPr>
          <p:cNvSpPr/>
          <p:nvPr/>
        </p:nvSpPr>
        <p:spPr>
          <a:xfrm>
            <a:off x="5001405" y="2845340"/>
            <a:ext cx="639129" cy="309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F62FADA1-280C-4954-8582-791681D7C0B3}"/>
              </a:ext>
            </a:extLst>
          </p:cNvPr>
          <p:cNvSpPr/>
          <p:nvPr/>
        </p:nvSpPr>
        <p:spPr>
          <a:xfrm>
            <a:off x="1912115" y="2839906"/>
            <a:ext cx="639129" cy="309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3E9D1DD1-19F2-4523-8376-E044DC418A20}"/>
              </a:ext>
            </a:extLst>
          </p:cNvPr>
          <p:cNvSpPr/>
          <p:nvPr/>
        </p:nvSpPr>
        <p:spPr>
          <a:xfrm>
            <a:off x="1891301" y="5404665"/>
            <a:ext cx="639129" cy="309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0FD14AD1-8293-48C1-846F-E10655726123}"/>
              </a:ext>
            </a:extLst>
          </p:cNvPr>
          <p:cNvSpPr/>
          <p:nvPr/>
        </p:nvSpPr>
        <p:spPr>
          <a:xfrm>
            <a:off x="1880223" y="8002109"/>
            <a:ext cx="639129" cy="309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7509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1</TotalTime>
  <Words>98</Words>
  <Application>Microsoft Office PowerPoint</Application>
  <PresentationFormat>A4 210 x 297 mm</PresentationFormat>
  <Paragraphs>7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6</cp:revision>
  <dcterms:created xsi:type="dcterms:W3CDTF">2020-12-17T08:55:34Z</dcterms:created>
  <dcterms:modified xsi:type="dcterms:W3CDTF">2022-04-25T03:24:40Z</dcterms:modified>
</cp:coreProperties>
</file>